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0" r:id="rId2"/>
    <p:sldId id="303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C0C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21" autoAdjust="0"/>
    <p:restoredTop sz="94660"/>
  </p:normalViewPr>
  <p:slideViewPr>
    <p:cSldViewPr>
      <p:cViewPr varScale="1">
        <p:scale>
          <a:sx n="64" d="100"/>
          <a:sy n="64" d="100"/>
        </p:scale>
        <p:origin x="1500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5F29BA-E517-461E-8B4F-8F4E14D2200B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A6F54B-40E9-4E9E-B454-19FAFA8DBF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2220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A69E915-EEED-4DF4-A5E4-9C0B4F626E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7F69A417-EA5F-4807-992A-81B8993D718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06383496"/>
              </p:ext>
            </p:extLst>
          </p:nvPr>
        </p:nvGraphicFramePr>
        <p:xfrm>
          <a:off x="134633" y="975320"/>
          <a:ext cx="8874733" cy="53340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961964">
                  <a:extLst>
                    <a:ext uri="{9D8B030D-6E8A-4147-A177-3AD203B41FA5}">
                      <a16:colId xmlns:a16="http://schemas.microsoft.com/office/drawing/2014/main" val="605078421"/>
                    </a:ext>
                  </a:extLst>
                </a:gridCol>
                <a:gridCol w="2304257">
                  <a:extLst>
                    <a:ext uri="{9D8B030D-6E8A-4147-A177-3AD203B41FA5}">
                      <a16:colId xmlns:a16="http://schemas.microsoft.com/office/drawing/2014/main" val="3856832685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665843864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2443726240"/>
                    </a:ext>
                  </a:extLst>
                </a:gridCol>
              </a:tblGrid>
              <a:tr h="9063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ems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  <a:p>
                      <a:pPr algn="ctr"/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,20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Face at Cong. or </a:t>
                      </a:r>
                      <a:r>
                        <a:rPr kumimoji="1" lang="en-US" altLang="ja-JP" sz="1400" i="1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;</a:t>
                      </a:r>
                      <a:b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,10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Gaze at Neutral, Angry, and Happy</a:t>
                      </a:r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]</a:t>
                      </a:r>
                      <a:endParaRPr kumimoji="1" lang="ja-JP" altLang="en-US" sz="1400" i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kumimoji="1" lang="ja-JP" altLang="en-US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η</a:t>
                      </a:r>
                      <a:r>
                        <a:rPr kumimoji="1" lang="ja-JP" altLang="en-US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ｐ</a:t>
                      </a:r>
                      <a:r>
                        <a:rPr kumimoji="1" lang="en-US" altLang="ja-JP" i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(partial </a:t>
                      </a:r>
                      <a:r>
                        <a:rPr lang="en-US" altLang="ja-JP" sz="14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η</a:t>
                      </a:r>
                      <a:r>
                        <a:rPr lang="en-US" altLang="ja-JP" sz="14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2</a:t>
                      </a: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)</a:t>
                      </a:r>
                      <a:endParaRPr lang="ja-JP" altLang="en-US" sz="20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996627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13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87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603205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kumimoji="1" lang="en-US" altLang="ja-JP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3.38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54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en-US" altLang="ja-JP" sz="180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53 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69520955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Neutr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62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57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en-US" altLang="ja-JP" sz="18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31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42765702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Angr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58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3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37 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53779331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Happ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6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en-US" altLang="ja-JP" sz="18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8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9971518"/>
                  </a:ext>
                </a:extLst>
              </a:tr>
            </a:tbl>
          </a:graphicData>
        </a:graphic>
      </p:graphicFrame>
      <p:sp>
        <p:nvSpPr>
          <p:cNvPr id="6" name="タイトル 1">
            <a:extLst>
              <a:ext uri="{FF2B5EF4-FFF2-40B4-BE49-F238E27FC236}">
                <a16:creationId xmlns:a16="http://schemas.microsoft.com/office/drawing/2014/main" id="{3705848B-A855-4543-B060-ACC0BB6018D6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7 Table: Reaction times for children.</a:t>
            </a:r>
            <a:br>
              <a:rPr lang="ja-JP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Simple main effect test after the interaction of ANOVA.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E59A94E-B9BD-4255-AE40-6F1B60DFF9B9}"/>
              </a:ext>
            </a:extLst>
          </p:cNvPr>
          <p:cNvSpPr txBox="1"/>
          <p:nvPr/>
        </p:nvSpPr>
        <p:spPr>
          <a:xfrm>
            <a:off x="1588958" y="6372036"/>
            <a:ext cx="75550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†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&lt; .1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35529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44328678-7ECE-4062-BF36-FE0EB2AE470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91608266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416915464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0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84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54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15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306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37.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77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45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455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121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3.02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1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38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44328678-7ECE-4062-BF36-FE0EB2AE470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91608266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416915464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0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028" t="-671" r="-1761" b="-273826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84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54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15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306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37.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77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45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455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121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3.02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1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38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4" name="タイトル 1">
            <a:extLst>
              <a:ext uri="{FF2B5EF4-FFF2-40B4-BE49-F238E27FC236}">
                <a16:creationId xmlns:a16="http://schemas.microsoft.com/office/drawing/2014/main" id="{C6E9579D-A7EE-4EF2-9229-9723EA44692A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b) Multiple comparisons between Face conditions at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ncong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6EF2913-5B22-4121-B956-928F0FE8FF07}"/>
              </a:ext>
            </a:extLst>
          </p:cNvPr>
          <p:cNvSpPr txBox="1"/>
          <p:nvPr/>
        </p:nvSpPr>
        <p:spPr>
          <a:xfrm>
            <a:off x="4571998" y="4283804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5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53207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69</TotalTime>
  <Words>186</Words>
  <Application>Microsoft Office PowerPoint</Application>
  <PresentationFormat>画面に合わせる (4:3)</PresentationFormat>
  <Paragraphs>5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ゴシック</vt:lpstr>
      <vt:lpstr>游明朝</vt:lpstr>
      <vt:lpstr>Arial</vt:lpstr>
      <vt:lpstr>Calibri</vt:lpstr>
      <vt:lpstr>Cambria Math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1. ERP responses (uV) in the children</dc:title>
  <dc:creator>USER</dc:creator>
  <cp:lastModifiedBy>柏原 考爾(kojikasi)</cp:lastModifiedBy>
  <cp:revision>965</cp:revision>
  <dcterms:created xsi:type="dcterms:W3CDTF">2019-08-15T18:36:33Z</dcterms:created>
  <dcterms:modified xsi:type="dcterms:W3CDTF">2022-04-04T18:34:36Z</dcterms:modified>
</cp:coreProperties>
</file>